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405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ke.minnick\Documents\PUBS\Bb%20EGF%20paper\Figures\S%20Figure%203B-%20graphs%20-07Nov2018%20TubeForm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ke.minnick\Documents\PUBS\Bb%20EGF%20paper\Figures\S%20Figure%203B-%20graphs%20-07Nov2018%20TubeForm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ke.minnick\Documents\PUBS\Bb%20EGF%20paper\Figures\S%20Figure%203B-%20graphs%20-07Nov2018%20TubeForma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03737569639565"/>
          <c:y val="8.5877803937961433E-2"/>
          <c:w val="0.86096262430360437"/>
          <c:h val="0.828244392124077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9</c:f>
              <c:strCache>
                <c:ptCount val="1"/>
                <c:pt idx="0">
                  <c:v>Avg # Nod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40:$C$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7499999999999996</c:v>
                  </c:pt>
                  <c:pt idx="2">
                    <c:v>16.75</c:v>
                  </c:pt>
                  <c:pt idx="3">
                    <c:v>2.9999999999999996</c:v>
                  </c:pt>
                  <c:pt idx="4">
                    <c:v>0</c:v>
                  </c:pt>
                  <c:pt idx="5">
                    <c:v>16.5</c:v>
                  </c:pt>
                  <c:pt idx="6">
                    <c:v>50.499999999999993</c:v>
                  </c:pt>
                </c:numCache>
              </c:numRef>
            </c:plus>
            <c:minus>
              <c:numRef>
                <c:f>Sheet1!$C$40:$C$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7499999999999996</c:v>
                  </c:pt>
                  <c:pt idx="2">
                    <c:v>16.75</c:v>
                  </c:pt>
                  <c:pt idx="3">
                    <c:v>2.9999999999999996</c:v>
                  </c:pt>
                  <c:pt idx="4">
                    <c:v>0</c:v>
                  </c:pt>
                  <c:pt idx="5">
                    <c:v>16.5</c:v>
                  </c:pt>
                  <c:pt idx="6">
                    <c:v>50.499999999999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0:$A$46</c:f>
              <c:strCache>
                <c:ptCount val="7"/>
                <c:pt idx="0">
                  <c:v>No FCS</c:v>
                </c:pt>
                <c:pt idx="1">
                  <c:v>VEGF</c:v>
                </c:pt>
                <c:pt idx="2">
                  <c:v>PCB</c:v>
                </c:pt>
                <c:pt idx="3">
                  <c:v>PCB pBBR1MCS2</c:v>
                </c:pt>
                <c:pt idx="4">
                  <c:v>PCB pBBR1MCS2 GroESL</c:v>
                </c:pt>
                <c:pt idx="5">
                  <c:v>PCB pBBR1MCS2 GroES (minus)</c:v>
                </c:pt>
                <c:pt idx="6">
                  <c:v>PCB pBBR1MCS2 GroESL D1</c:v>
                </c:pt>
              </c:strCache>
            </c:strRef>
          </c:cat>
          <c:val>
            <c:numRef>
              <c:f>Sheet1!$B$40:$B$46</c:f>
              <c:numCache>
                <c:formatCode>General</c:formatCode>
                <c:ptCount val="7"/>
                <c:pt idx="0">
                  <c:v>0</c:v>
                </c:pt>
                <c:pt idx="1">
                  <c:v>192.75</c:v>
                </c:pt>
                <c:pt idx="2">
                  <c:v>221.75</c:v>
                </c:pt>
                <c:pt idx="3">
                  <c:v>243</c:v>
                </c:pt>
                <c:pt idx="4">
                  <c:v>212.5</c:v>
                </c:pt>
                <c:pt idx="5">
                  <c:v>253.5</c:v>
                </c:pt>
                <c:pt idx="6">
                  <c:v>2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ED-42A5-88F1-ED3FA02B65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30493096"/>
        <c:axId val="230490144"/>
      </c:barChart>
      <c:catAx>
        <c:axId val="23049309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30490144"/>
        <c:crosses val="autoZero"/>
        <c:auto val="1"/>
        <c:lblAlgn val="ctr"/>
        <c:lblOffset val="100"/>
        <c:noMultiLvlLbl val="0"/>
      </c:catAx>
      <c:valAx>
        <c:axId val="2304901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0493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86718501829042"/>
          <c:y val="3.0852239203374883E-2"/>
          <c:w val="0.86913281498170958"/>
          <c:h val="0.729871849648243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39</c:f>
              <c:strCache>
                <c:ptCount val="1"/>
                <c:pt idx="0">
                  <c:v>Avg # Branch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40:$G$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25</c:v>
                  </c:pt>
                  <c:pt idx="2">
                    <c:v>2.25</c:v>
                  </c:pt>
                  <c:pt idx="3">
                    <c:v>1.25</c:v>
                  </c:pt>
                  <c:pt idx="4">
                    <c:v>1</c:v>
                  </c:pt>
                  <c:pt idx="5">
                    <c:v>5.75</c:v>
                  </c:pt>
                  <c:pt idx="6">
                    <c:v>11.999999999999998</c:v>
                  </c:pt>
                </c:numCache>
              </c:numRef>
            </c:plus>
            <c:minus>
              <c:numRef>
                <c:f>Sheet1!$G$40:$G$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.25</c:v>
                  </c:pt>
                  <c:pt idx="2">
                    <c:v>2.25</c:v>
                  </c:pt>
                  <c:pt idx="3">
                    <c:v>1.25</c:v>
                  </c:pt>
                  <c:pt idx="4">
                    <c:v>1</c:v>
                  </c:pt>
                  <c:pt idx="5">
                    <c:v>5.75</c:v>
                  </c:pt>
                  <c:pt idx="6">
                    <c:v>11.9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0:$A$46</c:f>
              <c:strCache>
                <c:ptCount val="7"/>
                <c:pt idx="0">
                  <c:v>No FCS</c:v>
                </c:pt>
                <c:pt idx="1">
                  <c:v>VEGF</c:v>
                </c:pt>
                <c:pt idx="2">
                  <c:v>PCB</c:v>
                </c:pt>
                <c:pt idx="3">
                  <c:v>PCB pBBR1MCS2</c:v>
                </c:pt>
                <c:pt idx="4">
                  <c:v>PCB pBBR1MCS2 GroESL</c:v>
                </c:pt>
                <c:pt idx="5">
                  <c:v>PCB pBBR1MCS2 GroES (minus)</c:v>
                </c:pt>
                <c:pt idx="6">
                  <c:v>PCB pBBR1MCS2 GroESL D1</c:v>
                </c:pt>
              </c:strCache>
            </c:strRef>
          </c:cat>
          <c:val>
            <c:numRef>
              <c:f>Sheet1!$F$40:$F$46</c:f>
              <c:numCache>
                <c:formatCode>General</c:formatCode>
                <c:ptCount val="7"/>
                <c:pt idx="0">
                  <c:v>0</c:v>
                </c:pt>
                <c:pt idx="1">
                  <c:v>45.25</c:v>
                </c:pt>
                <c:pt idx="2">
                  <c:v>45.25</c:v>
                </c:pt>
                <c:pt idx="3">
                  <c:v>50.75</c:v>
                </c:pt>
                <c:pt idx="4">
                  <c:v>45</c:v>
                </c:pt>
                <c:pt idx="5">
                  <c:v>48.75</c:v>
                </c:pt>
                <c:pt idx="6">
                  <c:v>46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1F-4D8C-B3C6-34A8D0E326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8163656"/>
        <c:axId val="378163328"/>
      </c:barChart>
      <c:catAx>
        <c:axId val="37816365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78163328"/>
        <c:crosses val="autoZero"/>
        <c:auto val="1"/>
        <c:lblAlgn val="ctr"/>
        <c:lblOffset val="100"/>
        <c:noMultiLvlLbl val="0"/>
      </c:catAx>
      <c:valAx>
        <c:axId val="378163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81636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89862448506623"/>
          <c:y val="9.5677491682381238E-2"/>
          <c:w val="0.8341013755149338"/>
          <c:h val="0.831506784053087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S Figure 3B- graphs -07Nov2018 TubeFormation.xlsx]Sheet1'!$O$40:$O$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4.5</c:v>
                  </c:pt>
                  <c:pt idx="2">
                    <c:v>6.4999999999999991</c:v>
                  </c:pt>
                  <c:pt idx="3">
                    <c:v>1.7499999999999998</c:v>
                  </c:pt>
                  <c:pt idx="4">
                    <c:v>1</c:v>
                  </c:pt>
                  <c:pt idx="5">
                    <c:v>5.9999999999999991</c:v>
                  </c:pt>
                  <c:pt idx="6">
                    <c:v>10.75</c:v>
                  </c:pt>
                </c:numCache>
              </c:numRef>
            </c:plus>
            <c:minus>
              <c:numRef>
                <c:f>'[S Figure 3B- graphs -07Nov2018 TubeFormation.xlsx]Sheet1'!$O$40:$O$4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4.5</c:v>
                  </c:pt>
                  <c:pt idx="2">
                    <c:v>6.4999999999999991</c:v>
                  </c:pt>
                  <c:pt idx="3">
                    <c:v>1.7499999999999998</c:v>
                  </c:pt>
                  <c:pt idx="4">
                    <c:v>1</c:v>
                  </c:pt>
                  <c:pt idx="5">
                    <c:v>5.9999999999999991</c:v>
                  </c:pt>
                  <c:pt idx="6">
                    <c:v>10.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 Figure 3B- graphs -07Nov2018 TubeFormation.xlsx]Sheet1'!$A$40:$A$46</c:f>
              <c:strCache>
                <c:ptCount val="7"/>
                <c:pt idx="0">
                  <c:v>No FCS</c:v>
                </c:pt>
                <c:pt idx="1">
                  <c:v>VEGF</c:v>
                </c:pt>
                <c:pt idx="2">
                  <c:v>PCB</c:v>
                </c:pt>
                <c:pt idx="3">
                  <c:v>PCB pBBR1MCS2</c:v>
                </c:pt>
                <c:pt idx="4">
                  <c:v>PCB pBBR1MCS2 GroESL</c:v>
                </c:pt>
                <c:pt idx="5">
                  <c:v>PCB pBBR1MCS2 GroES (minus)</c:v>
                </c:pt>
                <c:pt idx="6">
                  <c:v>PCB pBBR1MCS2 GroESL D1</c:v>
                </c:pt>
              </c:strCache>
            </c:strRef>
          </c:cat>
          <c:val>
            <c:numRef>
              <c:f>'[S Figure 3B- graphs -07Nov2018 TubeFormation.xlsx]Sheet1'!$N$40:$N$46</c:f>
              <c:numCache>
                <c:formatCode>General</c:formatCode>
                <c:ptCount val="7"/>
                <c:pt idx="0">
                  <c:v>0</c:v>
                </c:pt>
                <c:pt idx="1">
                  <c:v>76.5</c:v>
                </c:pt>
                <c:pt idx="2">
                  <c:v>85.5</c:v>
                </c:pt>
                <c:pt idx="3">
                  <c:v>90.75</c:v>
                </c:pt>
                <c:pt idx="4">
                  <c:v>80.5</c:v>
                </c:pt>
                <c:pt idx="5">
                  <c:v>92</c:v>
                </c:pt>
                <c:pt idx="6">
                  <c:v>9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91-4B27-82D7-B372A2B2F1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509920"/>
        <c:axId val="531508608"/>
      </c:barChart>
      <c:catAx>
        <c:axId val="53150992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31508608"/>
        <c:crosses val="autoZero"/>
        <c:auto val="1"/>
        <c:lblAlgn val="ctr"/>
        <c:lblOffset val="100"/>
        <c:noMultiLvlLbl val="0"/>
      </c:catAx>
      <c:valAx>
        <c:axId val="531508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1509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colors2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colors3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08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020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293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885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289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218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18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593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024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15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966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3DDA4-629E-40A2-AD26-A0F2BA08FD6F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48916-D6FA-4F13-88C8-0FE070BA9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71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chart" Target="../charts/chart3.xml"/><Relationship Id="rId5" Type="http://schemas.openxmlformats.org/officeDocument/2006/relationships/image" Target="../media/image4.tiff"/><Relationship Id="rId10" Type="http://schemas.openxmlformats.org/officeDocument/2006/relationships/chart" Target="../charts/chart2.xml"/><Relationship Id="rId4" Type="http://schemas.openxmlformats.org/officeDocument/2006/relationships/image" Target="../media/image3.tiff"/><Relationship Id="rId9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3328" y="2764852"/>
            <a:ext cx="1781377" cy="1781377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7341" y="2775267"/>
            <a:ext cx="1772137" cy="1765145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7993" y="2767152"/>
            <a:ext cx="1773081" cy="177326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0551" y="640723"/>
            <a:ext cx="1768927" cy="1768927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9626" y="640723"/>
            <a:ext cx="1781377" cy="1781377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3328" y="640723"/>
            <a:ext cx="1784353" cy="1784353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1260" y="640723"/>
            <a:ext cx="1759155" cy="1790123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2674208" y="320943"/>
            <a:ext cx="70062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 </a:t>
            </a:r>
            <a:r>
              <a:rPr lang="en-US" sz="1600" dirty="0" smtClean="0"/>
              <a:t> 1</a:t>
            </a:r>
            <a:r>
              <a:rPr lang="en-US" sz="1600" dirty="0" smtClean="0"/>
              <a:t>) None          </a:t>
            </a:r>
            <a:r>
              <a:rPr lang="en-US" sz="1600" dirty="0" smtClean="0"/>
              <a:t>                  2</a:t>
            </a:r>
            <a:r>
              <a:rPr lang="en-US" sz="1600" dirty="0" smtClean="0"/>
              <a:t>) VEGF       </a:t>
            </a:r>
            <a:r>
              <a:rPr lang="en-US" sz="1600" dirty="0" smtClean="0"/>
              <a:t>                     3</a:t>
            </a:r>
            <a:r>
              <a:rPr lang="en-US" sz="1600" dirty="0" smtClean="0"/>
              <a:t>) JB584        </a:t>
            </a:r>
            <a:r>
              <a:rPr lang="en-US" sz="1600" dirty="0" smtClean="0"/>
              <a:t>                   4</a:t>
            </a:r>
            <a:r>
              <a:rPr lang="en-US" sz="1600" dirty="0" smtClean="0"/>
              <a:t>) LSS001</a:t>
            </a:r>
            <a:endParaRPr lang="en-US" sz="1600" dirty="0"/>
          </a:p>
        </p:txBody>
      </p:sp>
      <p:sp>
        <p:nvSpPr>
          <p:cNvPr id="44" name="TextBox 43"/>
          <p:cNvSpPr txBox="1"/>
          <p:nvPr/>
        </p:nvSpPr>
        <p:spPr>
          <a:xfrm>
            <a:off x="2767396" y="2461796"/>
            <a:ext cx="49600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5) LSS100             </a:t>
            </a:r>
            <a:r>
              <a:rPr lang="en-US" sz="1600" dirty="0" smtClean="0"/>
              <a:t>            6</a:t>
            </a:r>
            <a:r>
              <a:rPr lang="en-US" sz="1600" dirty="0" smtClean="0"/>
              <a:t>) LSS500        </a:t>
            </a:r>
            <a:r>
              <a:rPr lang="en-US" sz="1600" dirty="0" smtClean="0"/>
              <a:t>                 </a:t>
            </a:r>
            <a:r>
              <a:rPr lang="en-US" sz="1600" dirty="0" smtClean="0"/>
              <a:t>7) LSS300</a:t>
            </a:r>
            <a:endParaRPr lang="en-US" sz="1600" dirty="0"/>
          </a:p>
        </p:txBody>
      </p:sp>
      <p:sp>
        <p:nvSpPr>
          <p:cNvPr id="45" name="TextBox 44"/>
          <p:cNvSpPr txBox="1"/>
          <p:nvPr/>
        </p:nvSpPr>
        <p:spPr>
          <a:xfrm>
            <a:off x="2020597" y="3132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020597" y="4813886"/>
            <a:ext cx="327318" cy="2570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2428842" y="4878027"/>
            <a:ext cx="8168434" cy="1379594"/>
            <a:chOff x="2428842" y="4878027"/>
            <a:chExt cx="8168434" cy="1379594"/>
          </a:xfrm>
        </p:grpSpPr>
        <p:sp>
          <p:nvSpPr>
            <p:cNvPr id="48" name="TextBox 47"/>
            <p:cNvSpPr txBox="1"/>
            <p:nvPr/>
          </p:nvSpPr>
          <p:spPr>
            <a:xfrm rot="16200000">
              <a:off x="4751315" y="5349599"/>
              <a:ext cx="128169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No. branches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 rot="16200000">
              <a:off x="7624069" y="5339335"/>
              <a:ext cx="9909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No. </a:t>
              </a:r>
              <a:r>
                <a:rPr lang="en-US" sz="1600" dirty="0" smtClean="0"/>
                <a:t>tubes</a:t>
              </a:r>
              <a:endParaRPr lang="en-US" sz="1600" dirty="0"/>
            </a:p>
          </p:txBody>
        </p:sp>
        <p:sp>
          <p:nvSpPr>
            <p:cNvPr id="50" name="TextBox 49"/>
            <p:cNvSpPr txBox="1"/>
            <p:nvPr/>
          </p:nvSpPr>
          <p:spPr>
            <a:xfrm rot="16200000">
              <a:off x="2082593" y="5310650"/>
              <a:ext cx="10310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No. nodes</a:t>
              </a:r>
              <a:endParaRPr lang="en-US" sz="16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012297" y="5955007"/>
              <a:ext cx="219643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1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3   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     5      6 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2" name="Chart 5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3633784"/>
                </p:ext>
              </p:extLst>
            </p:nvPr>
          </p:nvGraphicFramePr>
          <p:xfrm>
            <a:off x="2724494" y="4941874"/>
            <a:ext cx="2427481" cy="11322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53" name="Chart 5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75921859"/>
                </p:ext>
              </p:extLst>
            </p:nvPr>
          </p:nvGraphicFramePr>
          <p:xfrm>
            <a:off x="5466696" y="4964401"/>
            <a:ext cx="2445584" cy="12932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54" name="TextBox 53"/>
            <p:cNvSpPr txBox="1"/>
            <p:nvPr/>
          </p:nvSpPr>
          <p:spPr>
            <a:xfrm>
              <a:off x="5736109" y="5956786"/>
              <a:ext cx="227337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1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     3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     5 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      7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5" name="Chart 5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253800"/>
                </p:ext>
              </p:extLst>
            </p:nvPr>
          </p:nvGraphicFramePr>
          <p:xfrm>
            <a:off x="8127925" y="4880189"/>
            <a:ext cx="2462304" cy="11541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56" name="TextBox 55"/>
            <p:cNvSpPr txBox="1"/>
            <p:nvPr/>
          </p:nvSpPr>
          <p:spPr>
            <a:xfrm>
              <a:off x="8400841" y="5943315"/>
              <a:ext cx="219643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1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2   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     5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      7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613640" y="5192523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0301426" y="510005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</a:t>
              </a:r>
              <a:endParaRPr lang="en-US" sz="16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317538" y="511341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</a:t>
              </a:r>
              <a:endParaRPr lang="en-US" sz="16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859383" y="5061072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</a:t>
              </a:r>
              <a:endParaRPr lang="en-US" sz="16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324390" y="5282690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513382" y="5118494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917116" y="5170925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209722" y="5269330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050001" y="5191292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655496" y="5122040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6353478" y="5190334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6961588" y="5191292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8785868" y="5190334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9667633" y="5199931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9368834" y="5114647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9072835" y="5111588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9951800" y="5111588"/>
              <a:ext cx="3898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**</a:t>
              </a:r>
              <a:endParaRPr lang="en-US" sz="1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52391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74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nick, Mike</dc:creator>
  <cp:lastModifiedBy>Minnick, Mike</cp:lastModifiedBy>
  <cp:revision>11</cp:revision>
  <dcterms:created xsi:type="dcterms:W3CDTF">2020-01-14T22:35:56Z</dcterms:created>
  <dcterms:modified xsi:type="dcterms:W3CDTF">2020-03-30T17:02:51Z</dcterms:modified>
</cp:coreProperties>
</file>